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charts/style2.xml" ContentType="application/vnd.ms-office.chartstyle+xml"/>
  <Override PartName="/ppt/charts/style1.xml" ContentType="application/vnd.ms-office.chartstyl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charts/colors2.xml" ContentType="application/vnd.ms-office.chartcolorstyl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olors1.xml" ContentType="application/vnd.ms-office.chartcolorstyle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 snapToGrid="0">
      <p:cViewPr varScale="1">
        <p:scale>
          <a:sx n="83" d="100"/>
          <a:sy n="83" d="100"/>
        </p:scale>
        <p:origin x="-1032" y="-90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C:\Users\rahul\Desktop\U373MG_UP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oleObject" Target="file:///C:\Users\rahul\Desktop\U373MG_DOW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>
        <c:manualLayout>
          <c:layoutTarget val="inner"/>
          <c:xMode val="edge"/>
          <c:yMode val="edge"/>
          <c:x val="0.11281714785651795"/>
          <c:y val="1.7444009368824707E-2"/>
          <c:w val="0.87051618547681542"/>
          <c:h val="0.7933253478059491"/>
        </c:manualLayout>
      </c:layout>
      <c:barChart>
        <c:barDir val="col"/>
        <c:grouping val="clustered"/>
        <c:ser>
          <c:idx val="0"/>
          <c:order val="0"/>
          <c:tx>
            <c:strRef>
              <c:f>Sheet1!$A$28</c:f>
              <c:strCache>
                <c:ptCount val="1"/>
                <c:pt idx="0">
                  <c:v>Normoxi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Sheet1!$B$34:$H$34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Sheet1!$B$34:$H$34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27:$H$27</c:f>
              <c:strCache>
                <c:ptCount val="7"/>
                <c:pt idx="0">
                  <c:v>RNU6B</c:v>
                </c:pt>
                <c:pt idx="1">
                  <c:v>miR-210-3p</c:v>
                </c:pt>
                <c:pt idx="2">
                  <c:v>miR-1275</c:v>
                </c:pt>
                <c:pt idx="3">
                  <c:v>miR-376c-3p</c:v>
                </c:pt>
                <c:pt idx="4">
                  <c:v>miR-23b-3p</c:v>
                </c:pt>
                <c:pt idx="5">
                  <c:v>miR-193a-3p</c:v>
                </c:pt>
                <c:pt idx="6">
                  <c:v>miR-145-5p</c:v>
                </c:pt>
              </c:strCache>
            </c:strRef>
          </c:cat>
          <c:val>
            <c:numRef>
              <c:f>Sheet1!$B$28:$H$28</c:f>
              <c:numCache>
                <c:formatCode>General</c:formatCode>
                <c:ptCount val="7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1!$A$29</c:f>
              <c:strCache>
                <c:ptCount val="1"/>
                <c:pt idx="0">
                  <c:v>Hypoxi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Sheet1!$B$35:$H$35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18000000000000002</c:v>
                  </c:pt>
                  <c:pt idx="2">
                    <c:v>0.21000000000000002</c:v>
                  </c:pt>
                  <c:pt idx="3">
                    <c:v>0.11000000000000001</c:v>
                  </c:pt>
                  <c:pt idx="4">
                    <c:v>0.15000000000000002</c:v>
                  </c:pt>
                  <c:pt idx="5">
                    <c:v>8.0000000000000016E-2</c:v>
                  </c:pt>
                  <c:pt idx="6">
                    <c:v>0.2</c:v>
                  </c:pt>
                </c:numCache>
              </c:numRef>
            </c:plus>
            <c:minus>
              <c:numRef>
                <c:f>Sheet1!$B$35:$H$35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18000000000000002</c:v>
                  </c:pt>
                  <c:pt idx="2">
                    <c:v>0.21000000000000002</c:v>
                  </c:pt>
                  <c:pt idx="3">
                    <c:v>0.11000000000000001</c:v>
                  </c:pt>
                  <c:pt idx="4">
                    <c:v>0.15000000000000002</c:v>
                  </c:pt>
                  <c:pt idx="5">
                    <c:v>8.0000000000000016E-2</c:v>
                  </c:pt>
                  <c:pt idx="6">
                    <c:v>0.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27:$H$27</c:f>
              <c:strCache>
                <c:ptCount val="7"/>
                <c:pt idx="0">
                  <c:v>RNU6B</c:v>
                </c:pt>
                <c:pt idx="1">
                  <c:v>miR-210-3p</c:v>
                </c:pt>
                <c:pt idx="2">
                  <c:v>miR-1275</c:v>
                </c:pt>
                <c:pt idx="3">
                  <c:v>miR-376c-3p</c:v>
                </c:pt>
                <c:pt idx="4">
                  <c:v>miR-23b-3p</c:v>
                </c:pt>
                <c:pt idx="5">
                  <c:v>miR-193a-3p</c:v>
                </c:pt>
                <c:pt idx="6">
                  <c:v>miR-145-5p</c:v>
                </c:pt>
              </c:strCache>
            </c:strRef>
          </c:cat>
          <c:val>
            <c:numRef>
              <c:f>Sheet1!$B$29:$H$29</c:f>
              <c:numCache>
                <c:formatCode>General</c:formatCode>
                <c:ptCount val="7"/>
                <c:pt idx="0">
                  <c:v>1</c:v>
                </c:pt>
                <c:pt idx="1">
                  <c:v>4.7899148184757179</c:v>
                </c:pt>
                <c:pt idx="2">
                  <c:v>3.0525184179211169</c:v>
                </c:pt>
                <c:pt idx="3">
                  <c:v>1.1647335864684549</c:v>
                </c:pt>
                <c:pt idx="4">
                  <c:v>2.5847056612749801</c:v>
                </c:pt>
                <c:pt idx="5">
                  <c:v>1.3195079107728929</c:v>
                </c:pt>
                <c:pt idx="6">
                  <c:v>2.0705298476827569</c:v>
                </c:pt>
              </c:numCache>
            </c:numRef>
          </c:val>
        </c:ser>
        <c:dLbls/>
        <c:gapWidth val="219"/>
        <c:overlap val="-27"/>
        <c:axId val="70628096"/>
        <c:axId val="70629632"/>
      </c:barChart>
      <c:catAx>
        <c:axId val="70628096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0629632"/>
        <c:crosses val="autoZero"/>
        <c:auto val="1"/>
        <c:lblAlgn val="ctr"/>
        <c:lblOffset val="100"/>
      </c:catAx>
      <c:valAx>
        <c:axId val="70629632"/>
        <c:scaling>
          <c:orientation val="minMax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chemeClr val="tx1"/>
                    </a:solidFill>
                  </a:rPr>
                  <a:t>Fold</a:t>
                </a:r>
                <a:r>
                  <a:rPr lang="en-US" b="1" baseline="0">
                    <a:solidFill>
                      <a:schemeClr val="tx1"/>
                    </a:solidFill>
                  </a:rPr>
                  <a:t> Change</a:t>
                </a:r>
                <a:endParaRPr lang="en-US" b="1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2.7777777777777796E-3"/>
              <c:y val="0.3173339261787429"/>
            </c:manualLayout>
          </c:layout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tickLblPos val="nextTo"/>
        <c:spPr>
          <a:noFill/>
          <a:ln>
            <a:solidFill>
              <a:schemeClr val="bg2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06280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3593044619422579"/>
          <c:y val="2.1877304159065502E-3"/>
          <c:w val="0.28369444444444447"/>
          <c:h val="9.6644065325167713E-2"/>
        </c:manualLayout>
      </c:layout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>
        <c:manualLayout>
          <c:layoutTarget val="inner"/>
          <c:xMode val="edge"/>
          <c:yMode val="edge"/>
          <c:x val="0.14845603674540689"/>
          <c:y val="1.6812813168924242E-2"/>
          <c:w val="0.83487729658792664"/>
          <c:h val="0.81991767012081951"/>
        </c:manualLayout>
      </c:layout>
      <c:barChart>
        <c:barDir val="col"/>
        <c:grouping val="clustered"/>
        <c:ser>
          <c:idx val="0"/>
          <c:order val="0"/>
          <c:tx>
            <c:strRef>
              <c:f>Sheet1!$A$28</c:f>
              <c:strCache>
                <c:ptCount val="1"/>
                <c:pt idx="0">
                  <c:v>Normoxi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Sheet1!$B$34:$G$34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</c:numCache>
              </c:numRef>
            </c:plus>
            <c:minus>
              <c:numRef>
                <c:f>Sheet1!$B$34:$G$34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27:$G$27</c:f>
              <c:strCache>
                <c:ptCount val="6"/>
                <c:pt idx="0">
                  <c:v>RNU6B</c:v>
                </c:pt>
                <c:pt idx="1">
                  <c:v>miR-92b-3p</c:v>
                </c:pt>
                <c:pt idx="2">
                  <c:v>miR-20a-5p</c:v>
                </c:pt>
                <c:pt idx="3">
                  <c:v>miR-10b-5p</c:v>
                </c:pt>
                <c:pt idx="4">
                  <c:v>miR-181a-2-3p</c:v>
                </c:pt>
                <c:pt idx="5">
                  <c:v>miR-185-5p</c:v>
                </c:pt>
              </c:strCache>
            </c:strRef>
          </c:cat>
          <c:val>
            <c:numRef>
              <c:f>Sheet1!$B$28:$G$28</c:f>
              <c:numCache>
                <c:formatCode>General</c:formatCode>
                <c:ptCount val="6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1!$A$29</c:f>
              <c:strCache>
                <c:ptCount val="1"/>
                <c:pt idx="0">
                  <c:v>Hypoxi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Sheet1!$B$35:$G$35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16</c:v>
                  </c:pt>
                  <c:pt idx="2">
                    <c:v>7.0000000000000021E-2</c:v>
                  </c:pt>
                  <c:pt idx="3">
                    <c:v>3.0000000000000002E-2</c:v>
                  </c:pt>
                  <c:pt idx="4">
                    <c:v>0.22</c:v>
                  </c:pt>
                  <c:pt idx="5">
                    <c:v>0.12000000000000001</c:v>
                  </c:pt>
                </c:numCache>
              </c:numRef>
            </c:plus>
            <c:minus>
              <c:numRef>
                <c:f>Sheet1!$B$35:$G$35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16</c:v>
                  </c:pt>
                  <c:pt idx="2">
                    <c:v>7.0000000000000021E-2</c:v>
                  </c:pt>
                  <c:pt idx="3">
                    <c:v>3.0000000000000002E-2</c:v>
                  </c:pt>
                  <c:pt idx="4">
                    <c:v>0.22</c:v>
                  </c:pt>
                  <c:pt idx="5">
                    <c:v>0.1200000000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27:$G$27</c:f>
              <c:strCache>
                <c:ptCount val="6"/>
                <c:pt idx="0">
                  <c:v>RNU6B</c:v>
                </c:pt>
                <c:pt idx="1">
                  <c:v>miR-92b-3p</c:v>
                </c:pt>
                <c:pt idx="2">
                  <c:v>miR-20a-5p</c:v>
                </c:pt>
                <c:pt idx="3">
                  <c:v>miR-10b-5p</c:v>
                </c:pt>
                <c:pt idx="4">
                  <c:v>miR-181a-2-3p</c:v>
                </c:pt>
                <c:pt idx="5">
                  <c:v>miR-185-5p</c:v>
                </c:pt>
              </c:strCache>
            </c:strRef>
          </c:cat>
          <c:val>
            <c:numRef>
              <c:f>Sheet1!$B$29:$G$29</c:f>
              <c:numCache>
                <c:formatCode>General</c:formatCode>
                <c:ptCount val="6"/>
                <c:pt idx="0">
                  <c:v>1</c:v>
                </c:pt>
                <c:pt idx="1">
                  <c:v>0.42631744588397835</c:v>
                </c:pt>
                <c:pt idx="2">
                  <c:v>0.76312960448027944</c:v>
                </c:pt>
                <c:pt idx="3">
                  <c:v>1.1019051158766084</c:v>
                </c:pt>
                <c:pt idx="4">
                  <c:v>0.55478473603392342</c:v>
                </c:pt>
                <c:pt idx="5">
                  <c:v>0.61985384996949289</c:v>
                </c:pt>
              </c:numCache>
            </c:numRef>
          </c:val>
        </c:ser>
        <c:dLbls/>
        <c:gapWidth val="219"/>
        <c:overlap val="-27"/>
        <c:axId val="70930816"/>
        <c:axId val="70932352"/>
      </c:barChart>
      <c:catAx>
        <c:axId val="70930816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0932352"/>
        <c:crosses val="autoZero"/>
        <c:auto val="1"/>
        <c:lblAlgn val="ctr"/>
        <c:lblOffset val="100"/>
      </c:catAx>
      <c:valAx>
        <c:axId val="70932352"/>
        <c:scaling>
          <c:orientation val="minMax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chemeClr val="tx1"/>
                    </a:solidFill>
                  </a:rPr>
                  <a:t>Fold</a:t>
                </a:r>
                <a:r>
                  <a:rPr lang="en-US" b="1" baseline="0">
                    <a:solidFill>
                      <a:schemeClr val="tx1"/>
                    </a:solidFill>
                  </a:rPr>
                  <a:t> Change</a:t>
                </a:r>
                <a:endParaRPr lang="en-US" b="1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1.9167401639078537E-2"/>
              <c:y val="0.32827105084481045"/>
            </c:manualLayout>
          </c:layout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tickLblPos val="nextTo"/>
        <c:spPr>
          <a:noFill/>
          <a:ln>
            <a:solidFill>
              <a:schemeClr val="bg2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093081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4704155730533686"/>
          <c:y val="5.3601914137152359E-3"/>
          <c:w val="0.2948055555555556"/>
          <c:h val="9.2014435695538049E-2"/>
        </c:manualLayout>
      </c:layout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30427"/>
            <a:ext cx="84201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DF8C-EB3A-4D00-9F22-D9121B9EF7B8}" type="datetimeFigureOut">
              <a:rPr lang="en-US" smtClean="0"/>
              <a:pPr/>
              <a:t>6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E0C1-1639-4E9E-9676-B75B55A0B7B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DF8C-EB3A-4D00-9F22-D9121B9EF7B8}" type="datetimeFigureOut">
              <a:rPr lang="en-US" smtClean="0"/>
              <a:pPr/>
              <a:t>6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E0C1-1639-4E9E-9676-B75B55A0B7B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86387" y="396875"/>
            <a:ext cx="1671638" cy="84518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477" y="396875"/>
            <a:ext cx="4849813" cy="845185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DF8C-EB3A-4D00-9F22-D9121B9EF7B8}" type="datetimeFigureOut">
              <a:rPr lang="en-US" smtClean="0"/>
              <a:pPr/>
              <a:t>6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E0C1-1639-4E9E-9676-B75B55A0B7B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DF8C-EB3A-4D00-9F22-D9121B9EF7B8}" type="datetimeFigureOut">
              <a:rPr lang="en-US" smtClean="0"/>
              <a:pPr/>
              <a:t>6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E0C1-1639-4E9E-9676-B75B55A0B7B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506" y="2906715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DF8C-EB3A-4D00-9F22-D9121B9EF7B8}" type="datetimeFigureOut">
              <a:rPr lang="en-US" smtClean="0"/>
              <a:pPr/>
              <a:t>6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E0C1-1639-4E9E-9676-B75B55A0B7B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477" y="2311402"/>
            <a:ext cx="3260725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97302" y="2311402"/>
            <a:ext cx="3260725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DF8C-EB3A-4D00-9F22-D9121B9EF7B8}" type="datetimeFigureOut">
              <a:rPr lang="en-US" smtClean="0"/>
              <a:pPr/>
              <a:t>6/1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E0C1-1639-4E9E-9676-B75B55A0B7B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2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2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2113" y="1535113"/>
            <a:ext cx="4378589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2113" y="2174875"/>
            <a:ext cx="4378589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DF8C-EB3A-4D00-9F22-D9121B9EF7B8}" type="datetimeFigureOut">
              <a:rPr lang="en-US" smtClean="0"/>
              <a:pPr/>
              <a:t>6/12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E0C1-1639-4E9E-9676-B75B55A0B7B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DF8C-EB3A-4D00-9F22-D9121B9EF7B8}" type="datetimeFigureOut">
              <a:rPr lang="en-US" smtClean="0"/>
              <a:pPr/>
              <a:t>6/12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E0C1-1639-4E9E-9676-B75B55A0B7B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DF8C-EB3A-4D00-9F22-D9121B9EF7B8}" type="datetimeFigureOut">
              <a:rPr lang="en-US" smtClean="0"/>
              <a:pPr/>
              <a:t>6/12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E0C1-1639-4E9E-9676-B75B55A0B7B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2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2972" y="273052"/>
            <a:ext cx="553773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2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DF8C-EB3A-4D00-9F22-D9121B9EF7B8}" type="datetimeFigureOut">
              <a:rPr lang="en-US" smtClean="0"/>
              <a:pPr/>
              <a:t>6/1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E0C1-1639-4E9E-9676-B75B55A0B7B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DF8C-EB3A-4D00-9F22-D9121B9EF7B8}" type="datetimeFigureOut">
              <a:rPr lang="en-US" smtClean="0"/>
              <a:pPr/>
              <a:t>6/1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E0C1-1639-4E9E-9676-B75B55A0B7B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300" y="6356352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DDF8C-EB3A-4D00-9F22-D9121B9EF7B8}" type="datetimeFigureOut">
              <a:rPr lang="en-US" smtClean="0"/>
              <a:pPr/>
              <a:t>6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4550" y="6356352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9300" y="6356352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0BE0C1-1639-4E9E-9676-B75B55A0B7B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875969519"/>
              </p:ext>
            </p:extLst>
          </p:nvPr>
        </p:nvGraphicFramePr>
        <p:xfrm>
          <a:off x="251347" y="1337480"/>
          <a:ext cx="4525367" cy="41216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467160355"/>
              </p:ext>
            </p:extLst>
          </p:nvPr>
        </p:nvGraphicFramePr>
        <p:xfrm>
          <a:off x="4768756" y="1337480"/>
          <a:ext cx="4811972" cy="41489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Rectangle 3"/>
          <p:cNvSpPr/>
          <p:nvPr/>
        </p:nvSpPr>
        <p:spPr>
          <a:xfrm>
            <a:off x="136478" y="1214650"/>
            <a:ext cx="4640238" cy="44218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/>
          <p:cNvSpPr/>
          <p:nvPr/>
        </p:nvSpPr>
        <p:spPr>
          <a:xfrm>
            <a:off x="4776715" y="1214649"/>
            <a:ext cx="4981433" cy="44218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6" name="Group 5"/>
          <p:cNvGrpSpPr/>
          <p:nvPr/>
        </p:nvGrpSpPr>
        <p:grpSpPr>
          <a:xfrm flipH="1">
            <a:off x="1469669" y="1650069"/>
            <a:ext cx="215488" cy="284494"/>
            <a:chOff x="2098610" y="13752606"/>
            <a:chExt cx="129125" cy="3707634"/>
          </a:xfrm>
        </p:grpSpPr>
        <p:grpSp>
          <p:nvGrpSpPr>
            <p:cNvPr id="7" name="Group 6"/>
            <p:cNvGrpSpPr/>
            <p:nvPr/>
          </p:nvGrpSpPr>
          <p:grpSpPr>
            <a:xfrm>
              <a:off x="2098610" y="16487191"/>
              <a:ext cx="122814" cy="973049"/>
              <a:chOff x="1904203" y="4191000"/>
              <a:chExt cx="154784" cy="229394"/>
            </a:xfrm>
          </p:grpSpPr>
          <p:cxnSp>
            <p:nvCxnSpPr>
              <p:cNvPr id="9" name="Straight Connector 8"/>
              <p:cNvCxnSpPr/>
              <p:nvPr/>
            </p:nvCxnSpPr>
            <p:spPr>
              <a:xfrm rot="5400000">
                <a:off x="1790697" y="4305300"/>
                <a:ext cx="2286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9"/>
              <p:cNvCxnSpPr/>
              <p:nvPr/>
            </p:nvCxnSpPr>
            <p:spPr>
              <a:xfrm rot="10800000">
                <a:off x="1904999" y="4191000"/>
                <a:ext cx="153194" cy="79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/>
              <p:cNvCxnSpPr/>
              <p:nvPr/>
            </p:nvCxnSpPr>
            <p:spPr>
              <a:xfrm rot="5400000">
                <a:off x="1943893" y="4304506"/>
                <a:ext cx="2286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" name="TextBox 140"/>
            <p:cNvSpPr txBox="1"/>
            <p:nvPr/>
          </p:nvSpPr>
          <p:spPr>
            <a:xfrm>
              <a:off x="2104898" y="13752606"/>
              <a:ext cx="122837" cy="246951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/>
                <a:t>*</a:t>
              </a:r>
              <a:endParaRPr lang="en-US" sz="1100" dirty="0"/>
            </a:p>
          </p:txBody>
        </p:sp>
      </p:grpSp>
      <p:grpSp>
        <p:nvGrpSpPr>
          <p:cNvPr id="12" name="Group 11"/>
          <p:cNvGrpSpPr/>
          <p:nvPr/>
        </p:nvGrpSpPr>
        <p:grpSpPr>
          <a:xfrm flipH="1">
            <a:off x="2029228" y="2578116"/>
            <a:ext cx="215488" cy="284494"/>
            <a:chOff x="2098610" y="13752606"/>
            <a:chExt cx="129125" cy="3707634"/>
          </a:xfrm>
        </p:grpSpPr>
        <p:grpSp>
          <p:nvGrpSpPr>
            <p:cNvPr id="13" name="Group 12"/>
            <p:cNvGrpSpPr/>
            <p:nvPr/>
          </p:nvGrpSpPr>
          <p:grpSpPr>
            <a:xfrm>
              <a:off x="2098610" y="16487191"/>
              <a:ext cx="122814" cy="973049"/>
              <a:chOff x="1904203" y="4191000"/>
              <a:chExt cx="154784" cy="229394"/>
            </a:xfrm>
          </p:grpSpPr>
          <p:cxnSp>
            <p:nvCxnSpPr>
              <p:cNvPr id="15" name="Straight Connector 14"/>
              <p:cNvCxnSpPr/>
              <p:nvPr/>
            </p:nvCxnSpPr>
            <p:spPr>
              <a:xfrm rot="5400000">
                <a:off x="1790697" y="4305300"/>
                <a:ext cx="2286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/>
              <p:cNvCxnSpPr/>
              <p:nvPr/>
            </p:nvCxnSpPr>
            <p:spPr>
              <a:xfrm rot="10800000">
                <a:off x="1904999" y="4191000"/>
                <a:ext cx="153194" cy="79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Straight Connector 16"/>
              <p:cNvCxnSpPr/>
              <p:nvPr/>
            </p:nvCxnSpPr>
            <p:spPr>
              <a:xfrm rot="5400000">
                <a:off x="1943893" y="4304506"/>
                <a:ext cx="2286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" name="TextBox 140"/>
            <p:cNvSpPr txBox="1"/>
            <p:nvPr/>
          </p:nvSpPr>
          <p:spPr>
            <a:xfrm>
              <a:off x="2104898" y="13752606"/>
              <a:ext cx="122837" cy="246951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/>
                <a:t>*</a:t>
              </a:r>
              <a:endParaRPr lang="en-US" sz="1100" dirty="0"/>
            </a:p>
          </p:txBody>
        </p:sp>
      </p:grpSp>
      <p:grpSp>
        <p:nvGrpSpPr>
          <p:cNvPr id="18" name="Group 17"/>
          <p:cNvGrpSpPr/>
          <p:nvPr/>
        </p:nvGrpSpPr>
        <p:grpSpPr>
          <a:xfrm flipH="1">
            <a:off x="2602434" y="3656290"/>
            <a:ext cx="215488" cy="284494"/>
            <a:chOff x="2098610" y="13752606"/>
            <a:chExt cx="129125" cy="3707634"/>
          </a:xfrm>
        </p:grpSpPr>
        <p:grpSp>
          <p:nvGrpSpPr>
            <p:cNvPr id="19" name="Group 18"/>
            <p:cNvGrpSpPr/>
            <p:nvPr/>
          </p:nvGrpSpPr>
          <p:grpSpPr>
            <a:xfrm>
              <a:off x="2098610" y="16487191"/>
              <a:ext cx="122814" cy="973049"/>
              <a:chOff x="1904203" y="4191000"/>
              <a:chExt cx="154784" cy="229394"/>
            </a:xfrm>
          </p:grpSpPr>
          <p:cxnSp>
            <p:nvCxnSpPr>
              <p:cNvPr id="21" name="Straight Connector 20"/>
              <p:cNvCxnSpPr/>
              <p:nvPr/>
            </p:nvCxnSpPr>
            <p:spPr>
              <a:xfrm rot="5400000">
                <a:off x="1790697" y="4305300"/>
                <a:ext cx="2286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/>
              <p:cNvCxnSpPr/>
              <p:nvPr/>
            </p:nvCxnSpPr>
            <p:spPr>
              <a:xfrm rot="10800000">
                <a:off x="1904999" y="4191000"/>
                <a:ext cx="153194" cy="79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/>
              <p:cNvCxnSpPr/>
              <p:nvPr/>
            </p:nvCxnSpPr>
            <p:spPr>
              <a:xfrm rot="5400000">
                <a:off x="1943893" y="4304506"/>
                <a:ext cx="2286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" name="TextBox 140"/>
            <p:cNvSpPr txBox="1"/>
            <p:nvPr/>
          </p:nvSpPr>
          <p:spPr>
            <a:xfrm>
              <a:off x="2104898" y="13752606"/>
              <a:ext cx="122837" cy="246951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/>
                <a:t>*</a:t>
              </a:r>
              <a:endParaRPr lang="en-US" sz="1100" dirty="0"/>
            </a:p>
          </p:txBody>
        </p:sp>
      </p:grpSp>
      <p:grpSp>
        <p:nvGrpSpPr>
          <p:cNvPr id="24" name="Group 23"/>
          <p:cNvGrpSpPr/>
          <p:nvPr/>
        </p:nvGrpSpPr>
        <p:grpSpPr>
          <a:xfrm flipH="1">
            <a:off x="3702168" y="3591532"/>
            <a:ext cx="215488" cy="284494"/>
            <a:chOff x="2098610" y="13752606"/>
            <a:chExt cx="129125" cy="3707634"/>
          </a:xfrm>
        </p:grpSpPr>
        <p:grpSp>
          <p:nvGrpSpPr>
            <p:cNvPr id="25" name="Group 24"/>
            <p:cNvGrpSpPr/>
            <p:nvPr/>
          </p:nvGrpSpPr>
          <p:grpSpPr>
            <a:xfrm>
              <a:off x="2098610" y="16487191"/>
              <a:ext cx="122814" cy="973049"/>
              <a:chOff x="1904203" y="4191000"/>
              <a:chExt cx="154784" cy="229394"/>
            </a:xfrm>
          </p:grpSpPr>
          <p:cxnSp>
            <p:nvCxnSpPr>
              <p:cNvPr id="27" name="Straight Connector 26"/>
              <p:cNvCxnSpPr/>
              <p:nvPr/>
            </p:nvCxnSpPr>
            <p:spPr>
              <a:xfrm rot="5400000">
                <a:off x="1790697" y="4305300"/>
                <a:ext cx="2286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/>
              <p:cNvCxnSpPr/>
              <p:nvPr/>
            </p:nvCxnSpPr>
            <p:spPr>
              <a:xfrm rot="10800000">
                <a:off x="1904999" y="4191000"/>
                <a:ext cx="153194" cy="79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/>
              <p:cNvCxnSpPr/>
              <p:nvPr/>
            </p:nvCxnSpPr>
            <p:spPr>
              <a:xfrm rot="5400000">
                <a:off x="1943893" y="4304506"/>
                <a:ext cx="2286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6" name="TextBox 140"/>
            <p:cNvSpPr txBox="1"/>
            <p:nvPr/>
          </p:nvSpPr>
          <p:spPr>
            <a:xfrm>
              <a:off x="2104898" y="13752606"/>
              <a:ext cx="122837" cy="246951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/>
                <a:t>*</a:t>
              </a:r>
              <a:endParaRPr lang="en-US" sz="1100" dirty="0"/>
            </a:p>
          </p:txBody>
        </p:sp>
      </p:grpSp>
      <p:grpSp>
        <p:nvGrpSpPr>
          <p:cNvPr id="30" name="Group 29"/>
          <p:cNvGrpSpPr/>
          <p:nvPr/>
        </p:nvGrpSpPr>
        <p:grpSpPr>
          <a:xfrm flipH="1">
            <a:off x="4281108" y="3096471"/>
            <a:ext cx="215488" cy="284494"/>
            <a:chOff x="2098610" y="13752606"/>
            <a:chExt cx="129125" cy="3707634"/>
          </a:xfrm>
        </p:grpSpPr>
        <p:grpSp>
          <p:nvGrpSpPr>
            <p:cNvPr id="31" name="Group 30"/>
            <p:cNvGrpSpPr/>
            <p:nvPr/>
          </p:nvGrpSpPr>
          <p:grpSpPr>
            <a:xfrm>
              <a:off x="2098610" y="16487191"/>
              <a:ext cx="122814" cy="973049"/>
              <a:chOff x="1904203" y="4191000"/>
              <a:chExt cx="154784" cy="229394"/>
            </a:xfrm>
          </p:grpSpPr>
          <p:cxnSp>
            <p:nvCxnSpPr>
              <p:cNvPr id="33" name="Straight Connector 32"/>
              <p:cNvCxnSpPr/>
              <p:nvPr/>
            </p:nvCxnSpPr>
            <p:spPr>
              <a:xfrm rot="5400000">
                <a:off x="1790697" y="4305300"/>
                <a:ext cx="2286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/>
              <p:cNvCxnSpPr/>
              <p:nvPr/>
            </p:nvCxnSpPr>
            <p:spPr>
              <a:xfrm rot="10800000">
                <a:off x="1904999" y="4191000"/>
                <a:ext cx="153194" cy="79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/>
              <p:cNvCxnSpPr/>
              <p:nvPr/>
            </p:nvCxnSpPr>
            <p:spPr>
              <a:xfrm rot="5400000">
                <a:off x="1943893" y="4304506"/>
                <a:ext cx="2286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2" name="TextBox 140"/>
            <p:cNvSpPr txBox="1"/>
            <p:nvPr/>
          </p:nvSpPr>
          <p:spPr>
            <a:xfrm>
              <a:off x="2104898" y="13752606"/>
              <a:ext cx="122837" cy="246951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/>
                <a:t>*</a:t>
              </a:r>
              <a:endParaRPr lang="en-US" sz="1100" dirty="0"/>
            </a:p>
          </p:txBody>
        </p:sp>
      </p:grpSp>
      <p:sp>
        <p:nvSpPr>
          <p:cNvPr id="36" name="TextBox 140"/>
          <p:cNvSpPr txBox="1"/>
          <p:nvPr/>
        </p:nvSpPr>
        <p:spPr>
          <a:xfrm flipH="1">
            <a:off x="2510994" y="3656290"/>
            <a:ext cx="204994" cy="18949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smtClean="0"/>
              <a:t>*</a:t>
            </a:r>
            <a:endParaRPr lang="en-US" sz="1100" dirty="0"/>
          </a:p>
        </p:txBody>
      </p:sp>
      <p:sp>
        <p:nvSpPr>
          <p:cNvPr id="37" name="TextBox 140"/>
          <p:cNvSpPr txBox="1"/>
          <p:nvPr/>
        </p:nvSpPr>
        <p:spPr>
          <a:xfrm flipH="1">
            <a:off x="1377704" y="1642068"/>
            <a:ext cx="204994" cy="18949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smtClean="0"/>
              <a:t>*</a:t>
            </a:r>
            <a:endParaRPr lang="en-US" sz="1100" dirty="0"/>
          </a:p>
        </p:txBody>
      </p:sp>
      <p:grpSp>
        <p:nvGrpSpPr>
          <p:cNvPr id="38" name="Group 37"/>
          <p:cNvGrpSpPr/>
          <p:nvPr/>
        </p:nvGrpSpPr>
        <p:grpSpPr>
          <a:xfrm flipH="1">
            <a:off x="3160188" y="2867343"/>
            <a:ext cx="215488" cy="284494"/>
            <a:chOff x="2098610" y="13752606"/>
            <a:chExt cx="129125" cy="3707634"/>
          </a:xfrm>
        </p:grpSpPr>
        <p:grpSp>
          <p:nvGrpSpPr>
            <p:cNvPr id="39" name="Group 38"/>
            <p:cNvGrpSpPr/>
            <p:nvPr/>
          </p:nvGrpSpPr>
          <p:grpSpPr>
            <a:xfrm>
              <a:off x="2098610" y="16487191"/>
              <a:ext cx="122814" cy="973049"/>
              <a:chOff x="1904203" y="4191000"/>
              <a:chExt cx="154784" cy="229394"/>
            </a:xfrm>
          </p:grpSpPr>
          <p:cxnSp>
            <p:nvCxnSpPr>
              <p:cNvPr id="41" name="Straight Connector 40"/>
              <p:cNvCxnSpPr/>
              <p:nvPr/>
            </p:nvCxnSpPr>
            <p:spPr>
              <a:xfrm rot="5400000">
                <a:off x="1790697" y="4305300"/>
                <a:ext cx="2286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Connector 41"/>
              <p:cNvCxnSpPr/>
              <p:nvPr/>
            </p:nvCxnSpPr>
            <p:spPr>
              <a:xfrm rot="10800000">
                <a:off x="1904999" y="4191000"/>
                <a:ext cx="153194" cy="79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Connector 42"/>
              <p:cNvCxnSpPr/>
              <p:nvPr/>
            </p:nvCxnSpPr>
            <p:spPr>
              <a:xfrm rot="5400000">
                <a:off x="1943893" y="4304506"/>
                <a:ext cx="2286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0" name="TextBox 140"/>
            <p:cNvSpPr txBox="1"/>
            <p:nvPr/>
          </p:nvSpPr>
          <p:spPr>
            <a:xfrm>
              <a:off x="2104898" y="13752606"/>
              <a:ext cx="122837" cy="246951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/>
                <a:t>*</a:t>
              </a:r>
              <a:endParaRPr lang="en-US" sz="1100" dirty="0"/>
            </a:p>
          </p:txBody>
        </p:sp>
      </p:grpSp>
      <p:grpSp>
        <p:nvGrpSpPr>
          <p:cNvPr id="44" name="Group 43"/>
          <p:cNvGrpSpPr/>
          <p:nvPr/>
        </p:nvGrpSpPr>
        <p:grpSpPr>
          <a:xfrm flipH="1">
            <a:off x="6357841" y="1612607"/>
            <a:ext cx="215488" cy="284494"/>
            <a:chOff x="2098610" y="13752606"/>
            <a:chExt cx="129125" cy="3707634"/>
          </a:xfrm>
        </p:grpSpPr>
        <p:grpSp>
          <p:nvGrpSpPr>
            <p:cNvPr id="45" name="Group 44"/>
            <p:cNvGrpSpPr/>
            <p:nvPr/>
          </p:nvGrpSpPr>
          <p:grpSpPr>
            <a:xfrm>
              <a:off x="2098610" y="16487191"/>
              <a:ext cx="122814" cy="973049"/>
              <a:chOff x="1904203" y="4191000"/>
              <a:chExt cx="154784" cy="229394"/>
            </a:xfrm>
          </p:grpSpPr>
          <p:cxnSp>
            <p:nvCxnSpPr>
              <p:cNvPr id="47" name="Straight Connector 46"/>
              <p:cNvCxnSpPr/>
              <p:nvPr/>
            </p:nvCxnSpPr>
            <p:spPr>
              <a:xfrm rot="5400000">
                <a:off x="1790697" y="4305300"/>
                <a:ext cx="2286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Straight Connector 47"/>
              <p:cNvCxnSpPr/>
              <p:nvPr/>
            </p:nvCxnSpPr>
            <p:spPr>
              <a:xfrm rot="10800000">
                <a:off x="1904999" y="4191000"/>
                <a:ext cx="153194" cy="79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Straight Connector 48"/>
              <p:cNvCxnSpPr/>
              <p:nvPr/>
            </p:nvCxnSpPr>
            <p:spPr>
              <a:xfrm rot="5400000">
                <a:off x="1943893" y="4304506"/>
                <a:ext cx="2286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6" name="TextBox 140"/>
            <p:cNvSpPr txBox="1"/>
            <p:nvPr/>
          </p:nvSpPr>
          <p:spPr>
            <a:xfrm>
              <a:off x="2104898" y="13752606"/>
              <a:ext cx="122837" cy="246951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/>
                <a:t>*</a:t>
              </a:r>
              <a:endParaRPr lang="en-US" sz="1100" dirty="0"/>
            </a:p>
          </p:txBody>
        </p:sp>
      </p:grpSp>
      <p:grpSp>
        <p:nvGrpSpPr>
          <p:cNvPr id="50" name="Group 49"/>
          <p:cNvGrpSpPr/>
          <p:nvPr/>
        </p:nvGrpSpPr>
        <p:grpSpPr>
          <a:xfrm flipH="1">
            <a:off x="7049270" y="1627366"/>
            <a:ext cx="215488" cy="284494"/>
            <a:chOff x="2098610" y="13752606"/>
            <a:chExt cx="129125" cy="3707634"/>
          </a:xfrm>
        </p:grpSpPr>
        <p:grpSp>
          <p:nvGrpSpPr>
            <p:cNvPr id="51" name="Group 50"/>
            <p:cNvGrpSpPr/>
            <p:nvPr/>
          </p:nvGrpSpPr>
          <p:grpSpPr>
            <a:xfrm>
              <a:off x="2098610" y="16487191"/>
              <a:ext cx="122814" cy="973049"/>
              <a:chOff x="1904203" y="4191000"/>
              <a:chExt cx="154784" cy="229394"/>
            </a:xfrm>
          </p:grpSpPr>
          <p:cxnSp>
            <p:nvCxnSpPr>
              <p:cNvPr id="53" name="Straight Connector 52"/>
              <p:cNvCxnSpPr/>
              <p:nvPr/>
            </p:nvCxnSpPr>
            <p:spPr>
              <a:xfrm rot="5400000">
                <a:off x="1790697" y="4305300"/>
                <a:ext cx="2286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Straight Connector 53"/>
              <p:cNvCxnSpPr/>
              <p:nvPr/>
            </p:nvCxnSpPr>
            <p:spPr>
              <a:xfrm rot="10800000">
                <a:off x="1904999" y="4191000"/>
                <a:ext cx="153194" cy="79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Straight Connector 54"/>
              <p:cNvCxnSpPr/>
              <p:nvPr/>
            </p:nvCxnSpPr>
            <p:spPr>
              <a:xfrm rot="5400000">
                <a:off x="1943893" y="4304506"/>
                <a:ext cx="2286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2" name="TextBox 140"/>
            <p:cNvSpPr txBox="1"/>
            <p:nvPr/>
          </p:nvSpPr>
          <p:spPr>
            <a:xfrm>
              <a:off x="2104898" y="13752606"/>
              <a:ext cx="122837" cy="246951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/>
                <a:t>*</a:t>
              </a:r>
              <a:endParaRPr lang="en-US" sz="1100" dirty="0"/>
            </a:p>
          </p:txBody>
        </p:sp>
      </p:grpSp>
      <p:grpSp>
        <p:nvGrpSpPr>
          <p:cNvPr id="56" name="Group 55"/>
          <p:cNvGrpSpPr/>
          <p:nvPr/>
        </p:nvGrpSpPr>
        <p:grpSpPr>
          <a:xfrm flipH="1">
            <a:off x="7708970" y="1273521"/>
            <a:ext cx="215488" cy="284494"/>
            <a:chOff x="2098610" y="13752606"/>
            <a:chExt cx="129125" cy="3707634"/>
          </a:xfrm>
        </p:grpSpPr>
        <p:grpSp>
          <p:nvGrpSpPr>
            <p:cNvPr id="57" name="Group 56"/>
            <p:cNvGrpSpPr/>
            <p:nvPr/>
          </p:nvGrpSpPr>
          <p:grpSpPr>
            <a:xfrm>
              <a:off x="2098610" y="16487191"/>
              <a:ext cx="122814" cy="973049"/>
              <a:chOff x="1904203" y="4191000"/>
              <a:chExt cx="154784" cy="229394"/>
            </a:xfrm>
          </p:grpSpPr>
          <p:cxnSp>
            <p:nvCxnSpPr>
              <p:cNvPr id="59" name="Straight Connector 58"/>
              <p:cNvCxnSpPr/>
              <p:nvPr/>
            </p:nvCxnSpPr>
            <p:spPr>
              <a:xfrm rot="5400000">
                <a:off x="1790697" y="4305300"/>
                <a:ext cx="2286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Straight Connector 59"/>
              <p:cNvCxnSpPr/>
              <p:nvPr/>
            </p:nvCxnSpPr>
            <p:spPr>
              <a:xfrm rot="10800000">
                <a:off x="1904999" y="4191000"/>
                <a:ext cx="153194" cy="79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Straight Connector 60"/>
              <p:cNvCxnSpPr/>
              <p:nvPr/>
            </p:nvCxnSpPr>
            <p:spPr>
              <a:xfrm rot="5400000">
                <a:off x="1943893" y="4304506"/>
                <a:ext cx="2286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8" name="TextBox 140"/>
            <p:cNvSpPr txBox="1"/>
            <p:nvPr/>
          </p:nvSpPr>
          <p:spPr>
            <a:xfrm>
              <a:off x="2104898" y="13752606"/>
              <a:ext cx="122837" cy="246951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/>
                <a:t>*</a:t>
              </a:r>
              <a:endParaRPr lang="en-US" sz="1100" dirty="0"/>
            </a:p>
          </p:txBody>
        </p:sp>
      </p:grpSp>
      <p:grpSp>
        <p:nvGrpSpPr>
          <p:cNvPr id="62" name="Group 61"/>
          <p:cNvGrpSpPr/>
          <p:nvPr/>
        </p:nvGrpSpPr>
        <p:grpSpPr>
          <a:xfrm flipH="1">
            <a:off x="8384641" y="1625997"/>
            <a:ext cx="215488" cy="284494"/>
            <a:chOff x="2098610" y="13752606"/>
            <a:chExt cx="129125" cy="3707634"/>
          </a:xfrm>
        </p:grpSpPr>
        <p:grpSp>
          <p:nvGrpSpPr>
            <p:cNvPr id="63" name="Group 62"/>
            <p:cNvGrpSpPr/>
            <p:nvPr/>
          </p:nvGrpSpPr>
          <p:grpSpPr>
            <a:xfrm>
              <a:off x="2098610" y="16487191"/>
              <a:ext cx="122814" cy="973049"/>
              <a:chOff x="1904203" y="4191000"/>
              <a:chExt cx="154784" cy="229394"/>
            </a:xfrm>
          </p:grpSpPr>
          <p:cxnSp>
            <p:nvCxnSpPr>
              <p:cNvPr id="65" name="Straight Connector 64"/>
              <p:cNvCxnSpPr/>
              <p:nvPr/>
            </p:nvCxnSpPr>
            <p:spPr>
              <a:xfrm rot="5400000">
                <a:off x="1790697" y="4305300"/>
                <a:ext cx="2286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Straight Connector 65"/>
              <p:cNvCxnSpPr/>
              <p:nvPr/>
            </p:nvCxnSpPr>
            <p:spPr>
              <a:xfrm rot="10800000">
                <a:off x="1904999" y="4191000"/>
                <a:ext cx="153194" cy="79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Straight Connector 66"/>
              <p:cNvCxnSpPr/>
              <p:nvPr/>
            </p:nvCxnSpPr>
            <p:spPr>
              <a:xfrm rot="5400000">
                <a:off x="1943893" y="4304506"/>
                <a:ext cx="2286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4" name="TextBox 140"/>
            <p:cNvSpPr txBox="1"/>
            <p:nvPr/>
          </p:nvSpPr>
          <p:spPr>
            <a:xfrm>
              <a:off x="2104898" y="13752606"/>
              <a:ext cx="122837" cy="246951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/>
                <a:t>*</a:t>
              </a:r>
              <a:endParaRPr lang="en-US" sz="1100" dirty="0"/>
            </a:p>
          </p:txBody>
        </p:sp>
      </p:grpSp>
      <p:grpSp>
        <p:nvGrpSpPr>
          <p:cNvPr id="68" name="Group 67"/>
          <p:cNvGrpSpPr/>
          <p:nvPr/>
        </p:nvGrpSpPr>
        <p:grpSpPr>
          <a:xfrm flipH="1">
            <a:off x="9048774" y="1624426"/>
            <a:ext cx="215488" cy="284494"/>
            <a:chOff x="2098610" y="13752606"/>
            <a:chExt cx="129125" cy="3707634"/>
          </a:xfrm>
        </p:grpSpPr>
        <p:grpSp>
          <p:nvGrpSpPr>
            <p:cNvPr id="69" name="Group 68"/>
            <p:cNvGrpSpPr/>
            <p:nvPr/>
          </p:nvGrpSpPr>
          <p:grpSpPr>
            <a:xfrm>
              <a:off x="2098610" y="16487191"/>
              <a:ext cx="122814" cy="973049"/>
              <a:chOff x="1904203" y="4191000"/>
              <a:chExt cx="154784" cy="229394"/>
            </a:xfrm>
          </p:grpSpPr>
          <p:cxnSp>
            <p:nvCxnSpPr>
              <p:cNvPr id="71" name="Straight Connector 70"/>
              <p:cNvCxnSpPr/>
              <p:nvPr/>
            </p:nvCxnSpPr>
            <p:spPr>
              <a:xfrm rot="5400000">
                <a:off x="1790697" y="4305300"/>
                <a:ext cx="2286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Straight Connector 71"/>
              <p:cNvCxnSpPr/>
              <p:nvPr/>
            </p:nvCxnSpPr>
            <p:spPr>
              <a:xfrm rot="10800000">
                <a:off x="1904999" y="4191000"/>
                <a:ext cx="153194" cy="79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Straight Connector 72"/>
              <p:cNvCxnSpPr/>
              <p:nvPr/>
            </p:nvCxnSpPr>
            <p:spPr>
              <a:xfrm rot="5400000">
                <a:off x="1943893" y="4304506"/>
                <a:ext cx="2286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0" name="TextBox 140"/>
            <p:cNvSpPr txBox="1"/>
            <p:nvPr/>
          </p:nvSpPr>
          <p:spPr>
            <a:xfrm>
              <a:off x="2104898" y="13752606"/>
              <a:ext cx="122837" cy="246951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/>
                <a:t>*</a:t>
              </a:r>
              <a:endParaRPr lang="en-US" sz="1100" dirty="0"/>
            </a:p>
          </p:txBody>
        </p:sp>
      </p:grpSp>
      <p:sp>
        <p:nvSpPr>
          <p:cNvPr id="74" name="TextBox 140"/>
          <p:cNvSpPr txBox="1"/>
          <p:nvPr/>
        </p:nvSpPr>
        <p:spPr>
          <a:xfrm flipH="1">
            <a:off x="8312987" y="1612607"/>
            <a:ext cx="204994" cy="18949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smtClean="0"/>
              <a:t>*</a:t>
            </a:r>
            <a:endParaRPr lang="en-US" sz="1100" dirty="0"/>
          </a:p>
        </p:txBody>
      </p:sp>
      <p:sp>
        <p:nvSpPr>
          <p:cNvPr id="75" name="TextBox 1"/>
          <p:cNvSpPr txBox="1"/>
          <p:nvPr/>
        </p:nvSpPr>
        <p:spPr>
          <a:xfrm>
            <a:off x="161757" y="1214377"/>
            <a:ext cx="685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1"/>
          <p:cNvSpPr txBox="1"/>
          <p:nvPr/>
        </p:nvSpPr>
        <p:spPr>
          <a:xfrm>
            <a:off x="4776714" y="1214377"/>
            <a:ext cx="685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2</TotalTime>
  <Words>22</Words>
  <Application>Microsoft Office PowerPoint</Application>
  <PresentationFormat>A4 Paper (210x297 mm)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ITU</dc:creator>
  <cp:lastModifiedBy>RITU</cp:lastModifiedBy>
  <cp:revision>44</cp:revision>
  <dcterms:created xsi:type="dcterms:W3CDTF">2013-10-04T06:22:43Z</dcterms:created>
  <dcterms:modified xsi:type="dcterms:W3CDTF">2014-06-12T06:07:33Z</dcterms:modified>
</cp:coreProperties>
</file>